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1334" y="2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27774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77995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31544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49259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41977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27842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9972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70442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05778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87729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7023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62047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5608F51D-9938-4FF6-866E-480767C03A39}"/>
              </a:ext>
            </a:extLst>
          </p:cNvPr>
          <p:cNvSpPr/>
          <p:nvPr/>
        </p:nvSpPr>
        <p:spPr>
          <a:xfrm>
            <a:off x="1084104" y="5426339"/>
            <a:ext cx="697579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NMR studies in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/Nu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treated with gallic acid and myricetin.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R were performed to observe densitometric and morphological changes in the tumoral lesions, as well to discard metastatic processes during treatments (50 mg/kg in 2 alternate days per week, 4 weeks, peritumoral route). The tumor lesions were delimited with a white circle in the corresponding images to T1, T2 and STIR studies or 3D-reconstruction. Results are representative of two biological replicates (n = 5). NMR: nuclear magnetic resonance; T1/T2: longitudinal/transverse relaxation times; STIR: short-TI inversion recovery; 3D-R: 3D-reconstruction. </a:t>
            </a:r>
            <a:endParaRPr lang="es-MX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FAE4A6C4-F2E7-4FBE-9773-5D24A05BFBD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9680"/>
          <a:stretch/>
        </p:blipFill>
        <p:spPr>
          <a:xfrm>
            <a:off x="1031631" y="0"/>
            <a:ext cx="6928337" cy="5386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5565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18</Words>
  <Application>Microsoft Office PowerPoint</Application>
  <PresentationFormat>Presentación en pantalla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Varela Rodriguez</dc:creator>
  <cp:lastModifiedBy>Luis Varela Rodriguez</cp:lastModifiedBy>
  <cp:revision>2</cp:revision>
  <dcterms:created xsi:type="dcterms:W3CDTF">2019-06-20T19:26:14Z</dcterms:created>
  <dcterms:modified xsi:type="dcterms:W3CDTF">2019-07-17T02:29:47Z</dcterms:modified>
</cp:coreProperties>
</file>